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  <p:sldId id="262" r:id="rId4"/>
    <p:sldId id="265" r:id="rId5"/>
    <p:sldId id="263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A74B982-A4C7-4787-9F46-0F2F1AF73E46}" v="4" dt="2025-06-15T18:40:36.49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681" y="8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, Keyin" userId="6c4499eb-acba-4480-9c7a-93eedcce3b20" providerId="ADAL" clId="{8D9298CB-5810-4318-B219-5C3F089BDCB8}"/>
    <pc:docChg chg="undo custSel addSld delSld modSld">
      <pc:chgData name="Li, Keyin" userId="6c4499eb-acba-4480-9c7a-93eedcce3b20" providerId="ADAL" clId="{8D9298CB-5810-4318-B219-5C3F089BDCB8}" dt="2025-06-03T20:28:18.521" v="57" actId="14100"/>
      <pc:docMkLst>
        <pc:docMk/>
      </pc:docMkLst>
      <pc:sldChg chg="del">
        <pc:chgData name="Li, Keyin" userId="6c4499eb-acba-4480-9c7a-93eedcce3b20" providerId="ADAL" clId="{8D9298CB-5810-4318-B219-5C3F089BDCB8}" dt="2025-06-03T20:18:45.994" v="2" actId="47"/>
        <pc:sldMkLst>
          <pc:docMk/>
          <pc:sldMk cId="700326177" sldId="256"/>
        </pc:sldMkLst>
      </pc:sldChg>
      <pc:sldChg chg="new del">
        <pc:chgData name="Li, Keyin" userId="6c4499eb-acba-4480-9c7a-93eedcce3b20" providerId="ADAL" clId="{8D9298CB-5810-4318-B219-5C3F089BDCB8}" dt="2025-06-03T20:18:47.155" v="3" actId="47"/>
        <pc:sldMkLst>
          <pc:docMk/>
          <pc:sldMk cId="700550399" sldId="257"/>
        </pc:sldMkLst>
      </pc:sldChg>
      <pc:sldChg chg="addSp delSp modSp new mod setBg">
        <pc:chgData name="Li, Keyin" userId="6c4499eb-acba-4480-9c7a-93eedcce3b20" providerId="ADAL" clId="{8D9298CB-5810-4318-B219-5C3F089BDCB8}" dt="2025-06-03T20:26:26.752" v="34" actId="1076"/>
        <pc:sldMkLst>
          <pc:docMk/>
          <pc:sldMk cId="2694216885" sldId="258"/>
        </pc:sldMkLst>
        <pc:spChg chg="add mod">
          <ac:chgData name="Li, Keyin" userId="6c4499eb-acba-4480-9c7a-93eedcce3b20" providerId="ADAL" clId="{8D9298CB-5810-4318-B219-5C3F089BDCB8}" dt="2025-06-03T20:26:26.752" v="34" actId="1076"/>
          <ac:spMkLst>
            <pc:docMk/>
            <pc:sldMk cId="2694216885" sldId="258"/>
            <ac:spMk id="5" creationId="{7E6E2472-A23C-6CA6-9B60-278CDCB52382}"/>
          </ac:spMkLst>
        </pc:spChg>
        <pc:picChg chg="add mod">
          <ac:chgData name="Li, Keyin" userId="6c4499eb-acba-4480-9c7a-93eedcce3b20" providerId="ADAL" clId="{8D9298CB-5810-4318-B219-5C3F089BDCB8}" dt="2025-06-03T20:22:15.159" v="23" actId="26606"/>
          <ac:picMkLst>
            <pc:docMk/>
            <pc:sldMk cId="2694216885" sldId="258"/>
            <ac:picMk id="3" creationId="{41418CE0-D623-21C6-E813-A239C1C7815C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6:40.827" v="36" actId="1076"/>
        <pc:sldMkLst>
          <pc:docMk/>
          <pc:sldMk cId="722808516" sldId="259"/>
        </pc:sldMkLst>
        <pc:spChg chg="add mod">
          <ac:chgData name="Li, Keyin" userId="6c4499eb-acba-4480-9c7a-93eedcce3b20" providerId="ADAL" clId="{8D9298CB-5810-4318-B219-5C3F089BDCB8}" dt="2025-06-03T20:26:40.827" v="36" actId="1076"/>
          <ac:spMkLst>
            <pc:docMk/>
            <pc:sldMk cId="722808516" sldId="259"/>
            <ac:spMk id="5" creationId="{96C99152-8B75-141C-6783-8DDA67096F76}"/>
          </ac:spMkLst>
        </pc:spChg>
        <pc:picChg chg="add mod">
          <ac:chgData name="Li, Keyin" userId="6c4499eb-acba-4480-9c7a-93eedcce3b20" providerId="ADAL" clId="{8D9298CB-5810-4318-B219-5C3F089BDCB8}" dt="2025-06-03T20:22:57.845" v="24" actId="26606"/>
          <ac:picMkLst>
            <pc:docMk/>
            <pc:sldMk cId="722808516" sldId="259"/>
            <ac:picMk id="3" creationId="{F9936E23-1F8A-343F-3CA9-2B6E1A3C9211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6:47.519" v="38" actId="1076"/>
        <pc:sldMkLst>
          <pc:docMk/>
          <pc:sldMk cId="1077468988" sldId="260"/>
        </pc:sldMkLst>
        <pc:spChg chg="add mod">
          <ac:chgData name="Li, Keyin" userId="6c4499eb-acba-4480-9c7a-93eedcce3b20" providerId="ADAL" clId="{8D9298CB-5810-4318-B219-5C3F089BDCB8}" dt="2025-06-03T20:26:47.519" v="38" actId="1076"/>
          <ac:spMkLst>
            <pc:docMk/>
            <pc:sldMk cId="1077468988" sldId="260"/>
            <ac:spMk id="5" creationId="{CF7BDD05-9F9F-A9C6-DBA5-63CE2BDA3E2B}"/>
          </ac:spMkLst>
        </pc:spChg>
        <pc:picChg chg="add mod">
          <ac:chgData name="Li, Keyin" userId="6c4499eb-acba-4480-9c7a-93eedcce3b20" providerId="ADAL" clId="{8D9298CB-5810-4318-B219-5C3F089BDCB8}" dt="2025-06-03T20:23:11.528" v="25" actId="26606"/>
          <ac:picMkLst>
            <pc:docMk/>
            <pc:sldMk cId="1077468988" sldId="260"/>
            <ac:picMk id="3" creationId="{D0B70BBB-91D6-2E21-1296-2D1413DE1A8A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6:58.585" v="40" actId="1076"/>
        <pc:sldMkLst>
          <pc:docMk/>
          <pc:sldMk cId="1034922760" sldId="261"/>
        </pc:sldMkLst>
        <pc:spChg chg="add mod">
          <ac:chgData name="Li, Keyin" userId="6c4499eb-acba-4480-9c7a-93eedcce3b20" providerId="ADAL" clId="{8D9298CB-5810-4318-B219-5C3F089BDCB8}" dt="2025-06-03T20:26:58.585" v="40" actId="1076"/>
          <ac:spMkLst>
            <pc:docMk/>
            <pc:sldMk cId="1034922760" sldId="261"/>
            <ac:spMk id="5" creationId="{7BF2CDFD-4513-9378-ABFE-8B59C50E86A8}"/>
          </ac:spMkLst>
        </pc:spChg>
        <pc:picChg chg="add mod">
          <ac:chgData name="Li, Keyin" userId="6c4499eb-acba-4480-9c7a-93eedcce3b20" providerId="ADAL" clId="{8D9298CB-5810-4318-B219-5C3F089BDCB8}" dt="2025-06-03T20:23:24.691" v="26" actId="26606"/>
          <ac:picMkLst>
            <pc:docMk/>
            <pc:sldMk cId="1034922760" sldId="261"/>
            <ac:picMk id="3" creationId="{11793EF6-3C3C-F5C4-80EE-12C41ECAB1B7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7:06.374" v="42" actId="1076"/>
        <pc:sldMkLst>
          <pc:docMk/>
          <pc:sldMk cId="3915472306" sldId="262"/>
        </pc:sldMkLst>
        <pc:spChg chg="add mod">
          <ac:chgData name="Li, Keyin" userId="6c4499eb-acba-4480-9c7a-93eedcce3b20" providerId="ADAL" clId="{8D9298CB-5810-4318-B219-5C3F089BDCB8}" dt="2025-06-03T20:27:06.374" v="42" actId="1076"/>
          <ac:spMkLst>
            <pc:docMk/>
            <pc:sldMk cId="3915472306" sldId="262"/>
            <ac:spMk id="5" creationId="{F9E22BD0-5CB6-A45E-CEE5-CB3F0F95C251}"/>
          </ac:spMkLst>
        </pc:spChg>
        <pc:picChg chg="add mod">
          <ac:chgData name="Li, Keyin" userId="6c4499eb-acba-4480-9c7a-93eedcce3b20" providerId="ADAL" clId="{8D9298CB-5810-4318-B219-5C3F089BDCB8}" dt="2025-06-03T20:23:37.208" v="27" actId="26606"/>
          <ac:picMkLst>
            <pc:docMk/>
            <pc:sldMk cId="3915472306" sldId="262"/>
            <ac:picMk id="3" creationId="{07F8D08B-2764-9524-7DB8-A6BD5CB2A6D3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8:18.521" v="57" actId="14100"/>
        <pc:sldMkLst>
          <pc:docMk/>
          <pc:sldMk cId="1829533229" sldId="263"/>
        </pc:sldMkLst>
        <pc:spChg chg="add mod">
          <ac:chgData name="Li, Keyin" userId="6c4499eb-acba-4480-9c7a-93eedcce3b20" providerId="ADAL" clId="{8D9298CB-5810-4318-B219-5C3F089BDCB8}" dt="2025-06-03T20:28:18.521" v="57" actId="14100"/>
          <ac:spMkLst>
            <pc:docMk/>
            <pc:sldMk cId="1829533229" sldId="263"/>
            <ac:spMk id="5" creationId="{EA72D41C-C677-4DDA-B7AE-41BE7D158BF7}"/>
          </ac:spMkLst>
        </pc:spChg>
        <pc:picChg chg="add mod">
          <ac:chgData name="Li, Keyin" userId="6c4499eb-acba-4480-9c7a-93eedcce3b20" providerId="ADAL" clId="{8D9298CB-5810-4318-B219-5C3F089BDCB8}" dt="2025-06-03T20:23:40.918" v="28" actId="26606"/>
          <ac:picMkLst>
            <pc:docMk/>
            <pc:sldMk cId="1829533229" sldId="263"/>
            <ac:picMk id="3" creationId="{950616E2-0EA1-808A-070A-9DC4157C1263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7:21.590" v="46" actId="1076"/>
        <pc:sldMkLst>
          <pc:docMk/>
          <pc:sldMk cId="434652098" sldId="264"/>
        </pc:sldMkLst>
        <pc:spChg chg="add mod">
          <ac:chgData name="Li, Keyin" userId="6c4499eb-acba-4480-9c7a-93eedcce3b20" providerId="ADAL" clId="{8D9298CB-5810-4318-B219-5C3F089BDCB8}" dt="2025-06-03T20:27:21.590" v="46" actId="1076"/>
          <ac:spMkLst>
            <pc:docMk/>
            <pc:sldMk cId="434652098" sldId="264"/>
            <ac:spMk id="5" creationId="{F3CB91D2-339A-3D46-208D-2D56273613FE}"/>
          </ac:spMkLst>
        </pc:spChg>
        <pc:picChg chg="add mod">
          <ac:chgData name="Li, Keyin" userId="6c4499eb-acba-4480-9c7a-93eedcce3b20" providerId="ADAL" clId="{8D9298CB-5810-4318-B219-5C3F089BDCB8}" dt="2025-06-03T20:23:44.347" v="29" actId="26606"/>
          <ac:picMkLst>
            <pc:docMk/>
            <pc:sldMk cId="434652098" sldId="264"/>
            <ac:picMk id="3" creationId="{C919BCCD-88ED-ED66-0AA5-C31F4BBBA9C5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7:29.395" v="48" actId="1076"/>
        <pc:sldMkLst>
          <pc:docMk/>
          <pc:sldMk cId="1202523505" sldId="265"/>
        </pc:sldMkLst>
        <pc:spChg chg="add mod">
          <ac:chgData name="Li, Keyin" userId="6c4499eb-acba-4480-9c7a-93eedcce3b20" providerId="ADAL" clId="{8D9298CB-5810-4318-B219-5C3F089BDCB8}" dt="2025-06-03T20:27:29.395" v="48" actId="1076"/>
          <ac:spMkLst>
            <pc:docMk/>
            <pc:sldMk cId="1202523505" sldId="265"/>
            <ac:spMk id="5" creationId="{4F034829-A385-E18B-CAA4-66D26DDAF854}"/>
          </ac:spMkLst>
        </pc:spChg>
        <pc:picChg chg="add mod">
          <ac:chgData name="Li, Keyin" userId="6c4499eb-acba-4480-9c7a-93eedcce3b20" providerId="ADAL" clId="{8D9298CB-5810-4318-B219-5C3F089BDCB8}" dt="2025-06-03T20:23:46.823" v="30" actId="26606"/>
          <ac:picMkLst>
            <pc:docMk/>
            <pc:sldMk cId="1202523505" sldId="265"/>
            <ac:picMk id="3" creationId="{241436BE-94AB-0332-9B80-40AAB1C77338}"/>
          </ac:picMkLst>
        </pc:picChg>
      </pc:sldChg>
      <pc:sldChg chg="addSp modSp new mod setBg">
        <pc:chgData name="Li, Keyin" userId="6c4499eb-acba-4480-9c7a-93eedcce3b20" providerId="ADAL" clId="{8D9298CB-5810-4318-B219-5C3F089BDCB8}" dt="2025-06-03T20:27:39.292" v="50" actId="1076"/>
        <pc:sldMkLst>
          <pc:docMk/>
          <pc:sldMk cId="2077015142" sldId="266"/>
        </pc:sldMkLst>
        <pc:spChg chg="add mod">
          <ac:chgData name="Li, Keyin" userId="6c4499eb-acba-4480-9c7a-93eedcce3b20" providerId="ADAL" clId="{8D9298CB-5810-4318-B219-5C3F089BDCB8}" dt="2025-06-03T20:27:39.292" v="50" actId="1076"/>
          <ac:spMkLst>
            <pc:docMk/>
            <pc:sldMk cId="2077015142" sldId="266"/>
            <ac:spMk id="5" creationId="{A71394D4-838B-14AC-D091-465AE04CBA6F}"/>
          </ac:spMkLst>
        </pc:spChg>
        <pc:picChg chg="add mod">
          <ac:chgData name="Li, Keyin" userId="6c4499eb-acba-4480-9c7a-93eedcce3b20" providerId="ADAL" clId="{8D9298CB-5810-4318-B219-5C3F089BDCB8}" dt="2025-06-03T20:23:58.188" v="31" actId="26606"/>
          <ac:picMkLst>
            <pc:docMk/>
            <pc:sldMk cId="2077015142" sldId="266"/>
            <ac:picMk id="3" creationId="{AAD8C010-5698-AA5C-3F53-95B403CDB481}"/>
          </ac:picMkLst>
        </pc:picChg>
      </pc:sldChg>
    </pc:docChg>
  </pc:docChgLst>
  <pc:docChgLst>
    <pc:chgData name="Li, Keyin" userId="6c4499eb-acba-4480-9c7a-93eedcce3b20" providerId="ADAL" clId="{2A74B982-A4C7-4787-9F46-0F2F1AF73E46}"/>
    <pc:docChg chg="custSel delSld modSld sldOrd">
      <pc:chgData name="Li, Keyin" userId="6c4499eb-acba-4480-9c7a-93eedcce3b20" providerId="ADAL" clId="{2A74B982-A4C7-4787-9F46-0F2F1AF73E46}" dt="2025-06-15T18:40:44.940" v="26"/>
      <pc:docMkLst>
        <pc:docMk/>
      </pc:docMkLst>
      <pc:sldChg chg="addSp modSp mod">
        <pc:chgData name="Li, Keyin" userId="6c4499eb-acba-4480-9c7a-93eedcce3b20" providerId="ADAL" clId="{2A74B982-A4C7-4787-9F46-0F2F1AF73E46}" dt="2025-06-15T18:39:50.100" v="11" actId="1076"/>
        <pc:sldMkLst>
          <pc:docMk/>
          <pc:sldMk cId="2694216885" sldId="258"/>
        </pc:sldMkLst>
        <pc:spChg chg="add mod">
          <ac:chgData name="Li, Keyin" userId="6c4499eb-acba-4480-9c7a-93eedcce3b20" providerId="ADAL" clId="{2A74B982-A4C7-4787-9F46-0F2F1AF73E46}" dt="2025-06-15T18:39:50.100" v="11" actId="1076"/>
          <ac:spMkLst>
            <pc:docMk/>
            <pc:sldMk cId="2694216885" sldId="258"/>
            <ac:spMk id="4" creationId="{96C99152-8B75-141C-6783-8DDA67096F76}"/>
          </ac:spMkLst>
        </pc:spChg>
        <pc:picChg chg="add mod">
          <ac:chgData name="Li, Keyin" userId="6c4499eb-acba-4480-9c7a-93eedcce3b20" providerId="ADAL" clId="{2A74B982-A4C7-4787-9F46-0F2F1AF73E46}" dt="2025-06-15T18:39:50.100" v="11" actId="1076"/>
          <ac:picMkLst>
            <pc:docMk/>
            <pc:sldMk cId="2694216885" sldId="258"/>
            <ac:picMk id="2" creationId="{F9936E23-1F8A-343F-3CA9-2B6E1A3C9211}"/>
          </ac:picMkLst>
        </pc:picChg>
        <pc:picChg chg="mod modCrop">
          <ac:chgData name="Li, Keyin" userId="6c4499eb-acba-4480-9c7a-93eedcce3b20" providerId="ADAL" clId="{2A74B982-A4C7-4787-9F46-0F2F1AF73E46}" dt="2025-06-15T18:38:23.518" v="0" actId="732"/>
          <ac:picMkLst>
            <pc:docMk/>
            <pc:sldMk cId="2694216885" sldId="258"/>
            <ac:picMk id="3" creationId="{41418CE0-D623-21C6-E813-A239C1C7815C}"/>
          </ac:picMkLst>
        </pc:picChg>
      </pc:sldChg>
      <pc:sldChg chg="delSp modSp del mod">
        <pc:chgData name="Li, Keyin" userId="6c4499eb-acba-4480-9c7a-93eedcce3b20" providerId="ADAL" clId="{2A74B982-A4C7-4787-9F46-0F2F1AF73E46}" dt="2025-06-15T18:40:30.519" v="19" actId="47"/>
        <pc:sldMkLst>
          <pc:docMk/>
          <pc:sldMk cId="722808516" sldId="259"/>
        </pc:sldMkLst>
        <pc:spChg chg="del">
          <ac:chgData name="Li, Keyin" userId="6c4499eb-acba-4480-9c7a-93eedcce3b20" providerId="ADAL" clId="{2A74B982-A4C7-4787-9F46-0F2F1AF73E46}" dt="2025-06-15T18:39:44.548" v="9" actId="21"/>
          <ac:spMkLst>
            <pc:docMk/>
            <pc:sldMk cId="722808516" sldId="259"/>
            <ac:spMk id="5" creationId="{96C99152-8B75-141C-6783-8DDA67096F76}"/>
          </ac:spMkLst>
        </pc:spChg>
        <pc:picChg chg="del mod modCrop">
          <ac:chgData name="Li, Keyin" userId="6c4499eb-acba-4480-9c7a-93eedcce3b20" providerId="ADAL" clId="{2A74B982-A4C7-4787-9F46-0F2F1AF73E46}" dt="2025-06-15T18:39:44.548" v="9" actId="21"/>
          <ac:picMkLst>
            <pc:docMk/>
            <pc:sldMk cId="722808516" sldId="259"/>
            <ac:picMk id="3" creationId="{F9936E23-1F8A-343F-3CA9-2B6E1A3C9211}"/>
          </ac:picMkLst>
        </pc:picChg>
      </pc:sldChg>
      <pc:sldChg chg="addSp modSp mod">
        <pc:chgData name="Li, Keyin" userId="6c4499eb-acba-4480-9c7a-93eedcce3b20" providerId="ADAL" clId="{2A74B982-A4C7-4787-9F46-0F2F1AF73E46}" dt="2025-06-15T18:40:01.653" v="14" actId="1076"/>
        <pc:sldMkLst>
          <pc:docMk/>
          <pc:sldMk cId="1077468988" sldId="260"/>
        </pc:sldMkLst>
        <pc:spChg chg="add mod">
          <ac:chgData name="Li, Keyin" userId="6c4499eb-acba-4480-9c7a-93eedcce3b20" providerId="ADAL" clId="{2A74B982-A4C7-4787-9F46-0F2F1AF73E46}" dt="2025-06-15T18:40:01.653" v="14" actId="1076"/>
          <ac:spMkLst>
            <pc:docMk/>
            <pc:sldMk cId="1077468988" sldId="260"/>
            <ac:spMk id="4" creationId="{7BF2CDFD-4513-9378-ABFE-8B59C50E86A8}"/>
          </ac:spMkLst>
        </pc:spChg>
        <pc:picChg chg="add mod">
          <ac:chgData name="Li, Keyin" userId="6c4499eb-acba-4480-9c7a-93eedcce3b20" providerId="ADAL" clId="{2A74B982-A4C7-4787-9F46-0F2F1AF73E46}" dt="2025-06-15T18:40:01.653" v="14" actId="1076"/>
          <ac:picMkLst>
            <pc:docMk/>
            <pc:sldMk cId="1077468988" sldId="260"/>
            <ac:picMk id="2" creationId="{11793EF6-3C3C-F5C4-80EE-12C41ECAB1B7}"/>
          </ac:picMkLst>
        </pc:picChg>
        <pc:picChg chg="mod modCrop">
          <ac:chgData name="Li, Keyin" userId="6c4499eb-acba-4480-9c7a-93eedcce3b20" providerId="ADAL" clId="{2A74B982-A4C7-4787-9F46-0F2F1AF73E46}" dt="2025-06-15T18:38:49.922" v="2" actId="732"/>
          <ac:picMkLst>
            <pc:docMk/>
            <pc:sldMk cId="1077468988" sldId="260"/>
            <ac:picMk id="3" creationId="{D0B70BBB-91D6-2E21-1296-2D1413DE1A8A}"/>
          </ac:picMkLst>
        </pc:picChg>
      </pc:sldChg>
      <pc:sldChg chg="delSp modSp del mod">
        <pc:chgData name="Li, Keyin" userId="6c4499eb-acba-4480-9c7a-93eedcce3b20" providerId="ADAL" clId="{2A74B982-A4C7-4787-9F46-0F2F1AF73E46}" dt="2025-06-15T18:40:29.549" v="18" actId="47"/>
        <pc:sldMkLst>
          <pc:docMk/>
          <pc:sldMk cId="1034922760" sldId="261"/>
        </pc:sldMkLst>
        <pc:spChg chg="del">
          <ac:chgData name="Li, Keyin" userId="6c4499eb-acba-4480-9c7a-93eedcce3b20" providerId="ADAL" clId="{2A74B982-A4C7-4787-9F46-0F2F1AF73E46}" dt="2025-06-15T18:39:56.482" v="12" actId="21"/>
          <ac:spMkLst>
            <pc:docMk/>
            <pc:sldMk cId="1034922760" sldId="261"/>
            <ac:spMk id="5" creationId="{7BF2CDFD-4513-9378-ABFE-8B59C50E86A8}"/>
          </ac:spMkLst>
        </pc:spChg>
        <pc:picChg chg="del mod modCrop">
          <ac:chgData name="Li, Keyin" userId="6c4499eb-acba-4480-9c7a-93eedcce3b20" providerId="ADAL" clId="{2A74B982-A4C7-4787-9F46-0F2F1AF73E46}" dt="2025-06-15T18:39:56.482" v="12" actId="21"/>
          <ac:picMkLst>
            <pc:docMk/>
            <pc:sldMk cId="1034922760" sldId="261"/>
            <ac:picMk id="3" creationId="{11793EF6-3C3C-F5C4-80EE-12C41ECAB1B7}"/>
          </ac:picMkLst>
        </pc:picChg>
      </pc:sldChg>
      <pc:sldChg chg="addSp modSp mod">
        <pc:chgData name="Li, Keyin" userId="6c4499eb-acba-4480-9c7a-93eedcce3b20" providerId="ADAL" clId="{2A74B982-A4C7-4787-9F46-0F2F1AF73E46}" dt="2025-06-15T18:40:26.689" v="17" actId="1076"/>
        <pc:sldMkLst>
          <pc:docMk/>
          <pc:sldMk cId="3915472306" sldId="262"/>
        </pc:sldMkLst>
        <pc:spChg chg="add mod">
          <ac:chgData name="Li, Keyin" userId="6c4499eb-acba-4480-9c7a-93eedcce3b20" providerId="ADAL" clId="{2A74B982-A4C7-4787-9F46-0F2F1AF73E46}" dt="2025-06-15T18:40:26.689" v="17" actId="1076"/>
          <ac:spMkLst>
            <pc:docMk/>
            <pc:sldMk cId="3915472306" sldId="262"/>
            <ac:spMk id="4" creationId="{F3CB91D2-339A-3D46-208D-2D56273613FE}"/>
          </ac:spMkLst>
        </pc:spChg>
        <pc:picChg chg="add mod">
          <ac:chgData name="Li, Keyin" userId="6c4499eb-acba-4480-9c7a-93eedcce3b20" providerId="ADAL" clId="{2A74B982-A4C7-4787-9F46-0F2F1AF73E46}" dt="2025-06-15T18:40:26.689" v="17" actId="1076"/>
          <ac:picMkLst>
            <pc:docMk/>
            <pc:sldMk cId="3915472306" sldId="262"/>
            <ac:picMk id="2" creationId="{C919BCCD-88ED-ED66-0AA5-C31F4BBBA9C5}"/>
          </ac:picMkLst>
        </pc:picChg>
        <pc:picChg chg="mod modCrop">
          <ac:chgData name="Li, Keyin" userId="6c4499eb-acba-4480-9c7a-93eedcce3b20" providerId="ADAL" clId="{2A74B982-A4C7-4787-9F46-0F2F1AF73E46}" dt="2025-06-15T18:39:05.280" v="4" actId="732"/>
          <ac:picMkLst>
            <pc:docMk/>
            <pc:sldMk cId="3915472306" sldId="262"/>
            <ac:picMk id="3" creationId="{07F8D08B-2764-9524-7DB8-A6BD5CB2A6D3}"/>
          </ac:picMkLst>
        </pc:picChg>
      </pc:sldChg>
      <pc:sldChg chg="modSp mod">
        <pc:chgData name="Li, Keyin" userId="6c4499eb-acba-4480-9c7a-93eedcce3b20" providerId="ADAL" clId="{2A74B982-A4C7-4787-9F46-0F2F1AF73E46}" dt="2025-06-15T18:39:13.627" v="5" actId="732"/>
        <pc:sldMkLst>
          <pc:docMk/>
          <pc:sldMk cId="1829533229" sldId="263"/>
        </pc:sldMkLst>
        <pc:picChg chg="mod modCrop">
          <ac:chgData name="Li, Keyin" userId="6c4499eb-acba-4480-9c7a-93eedcce3b20" providerId="ADAL" clId="{2A74B982-A4C7-4787-9F46-0F2F1AF73E46}" dt="2025-06-15T18:39:13.627" v="5" actId="732"/>
          <ac:picMkLst>
            <pc:docMk/>
            <pc:sldMk cId="1829533229" sldId="263"/>
            <ac:picMk id="3" creationId="{950616E2-0EA1-808A-070A-9DC4157C1263}"/>
          </ac:picMkLst>
        </pc:picChg>
      </pc:sldChg>
      <pc:sldChg chg="delSp modSp del mod">
        <pc:chgData name="Li, Keyin" userId="6c4499eb-acba-4480-9c7a-93eedcce3b20" providerId="ADAL" clId="{2A74B982-A4C7-4787-9F46-0F2F1AF73E46}" dt="2025-06-15T18:40:42.650" v="24" actId="47"/>
        <pc:sldMkLst>
          <pc:docMk/>
          <pc:sldMk cId="434652098" sldId="264"/>
        </pc:sldMkLst>
        <pc:spChg chg="del">
          <ac:chgData name="Li, Keyin" userId="6c4499eb-acba-4480-9c7a-93eedcce3b20" providerId="ADAL" clId="{2A74B982-A4C7-4787-9F46-0F2F1AF73E46}" dt="2025-06-15T18:40:22.452" v="15" actId="21"/>
          <ac:spMkLst>
            <pc:docMk/>
            <pc:sldMk cId="434652098" sldId="264"/>
            <ac:spMk id="5" creationId="{F3CB91D2-339A-3D46-208D-2D56273613FE}"/>
          </ac:spMkLst>
        </pc:spChg>
        <pc:picChg chg="del mod modCrop">
          <ac:chgData name="Li, Keyin" userId="6c4499eb-acba-4480-9c7a-93eedcce3b20" providerId="ADAL" clId="{2A74B982-A4C7-4787-9F46-0F2F1AF73E46}" dt="2025-06-15T18:40:22.452" v="15" actId="21"/>
          <ac:picMkLst>
            <pc:docMk/>
            <pc:sldMk cId="434652098" sldId="264"/>
            <ac:picMk id="3" creationId="{C919BCCD-88ED-ED66-0AA5-C31F4BBBA9C5}"/>
          </ac:picMkLst>
        </pc:picChg>
      </pc:sldChg>
      <pc:sldChg chg="addSp modSp mod ord">
        <pc:chgData name="Li, Keyin" userId="6c4499eb-acba-4480-9c7a-93eedcce3b20" providerId="ADAL" clId="{2A74B982-A4C7-4787-9F46-0F2F1AF73E46}" dt="2025-06-15T18:40:44.940" v="26"/>
        <pc:sldMkLst>
          <pc:docMk/>
          <pc:sldMk cId="1202523505" sldId="265"/>
        </pc:sldMkLst>
        <pc:spChg chg="add mod">
          <ac:chgData name="Li, Keyin" userId="6c4499eb-acba-4480-9c7a-93eedcce3b20" providerId="ADAL" clId="{2A74B982-A4C7-4787-9F46-0F2F1AF73E46}" dt="2025-06-15T18:40:39.132" v="22" actId="1076"/>
          <ac:spMkLst>
            <pc:docMk/>
            <pc:sldMk cId="1202523505" sldId="265"/>
            <ac:spMk id="4" creationId="{A71394D4-838B-14AC-D091-465AE04CBA6F}"/>
          </ac:spMkLst>
        </pc:spChg>
        <pc:picChg chg="add mod">
          <ac:chgData name="Li, Keyin" userId="6c4499eb-acba-4480-9c7a-93eedcce3b20" providerId="ADAL" clId="{2A74B982-A4C7-4787-9F46-0F2F1AF73E46}" dt="2025-06-15T18:40:39.132" v="22" actId="1076"/>
          <ac:picMkLst>
            <pc:docMk/>
            <pc:sldMk cId="1202523505" sldId="265"/>
            <ac:picMk id="2" creationId="{AAD8C010-5698-AA5C-3F53-95B403CDB481}"/>
          </ac:picMkLst>
        </pc:picChg>
        <pc:picChg chg="mod modCrop">
          <ac:chgData name="Li, Keyin" userId="6c4499eb-acba-4480-9c7a-93eedcce3b20" providerId="ADAL" clId="{2A74B982-A4C7-4787-9F46-0F2F1AF73E46}" dt="2025-06-15T18:39:27.815" v="7" actId="732"/>
          <ac:picMkLst>
            <pc:docMk/>
            <pc:sldMk cId="1202523505" sldId="265"/>
            <ac:picMk id="3" creationId="{241436BE-94AB-0332-9B80-40AAB1C77338}"/>
          </ac:picMkLst>
        </pc:picChg>
      </pc:sldChg>
      <pc:sldChg chg="delSp modSp del mod">
        <pc:chgData name="Li, Keyin" userId="6c4499eb-acba-4480-9c7a-93eedcce3b20" providerId="ADAL" clId="{2A74B982-A4C7-4787-9F46-0F2F1AF73E46}" dt="2025-06-15T18:40:41.757" v="23" actId="47"/>
        <pc:sldMkLst>
          <pc:docMk/>
          <pc:sldMk cId="2077015142" sldId="266"/>
        </pc:sldMkLst>
        <pc:spChg chg="del">
          <ac:chgData name="Li, Keyin" userId="6c4499eb-acba-4480-9c7a-93eedcce3b20" providerId="ADAL" clId="{2A74B982-A4C7-4787-9F46-0F2F1AF73E46}" dt="2025-06-15T18:40:35.129" v="20" actId="21"/>
          <ac:spMkLst>
            <pc:docMk/>
            <pc:sldMk cId="2077015142" sldId="266"/>
            <ac:spMk id="5" creationId="{A71394D4-838B-14AC-D091-465AE04CBA6F}"/>
          </ac:spMkLst>
        </pc:spChg>
        <pc:picChg chg="del mod modCrop">
          <ac:chgData name="Li, Keyin" userId="6c4499eb-acba-4480-9c7a-93eedcce3b20" providerId="ADAL" clId="{2A74B982-A4C7-4787-9F46-0F2F1AF73E46}" dt="2025-06-15T18:40:35.129" v="20" actId="21"/>
          <ac:picMkLst>
            <pc:docMk/>
            <pc:sldMk cId="2077015142" sldId="266"/>
            <ac:picMk id="3" creationId="{AAD8C010-5698-AA5C-3F53-95B403CDB48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17E6F7-23AC-6204-6904-47987655FF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6385FE-E6E1-7605-FEB9-7C67586A96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8B59DF-FCC3-4BFC-D221-A4A1E6A478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94CC77-8FBB-7678-1B1A-5902E48C16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7860F-795B-CA06-34E7-BEEC45D04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3291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EABCE-5088-B937-EFFE-138F3C5F02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619F0B9-37EB-7533-6AC5-45A1EA5E0E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196CB2-9951-E755-E82E-B541CACD8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E05E69-93F6-A38D-0D57-2E1446D63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66BFA2-B093-4305-8883-CFE5485A7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5669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7FE8D6E-9C74-D192-805D-D0F84408EB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76E6140-314B-B333-2F10-C1F425970D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FA4601-FA3F-9044-70AB-18D7D6250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6736CF1-C4A7-3FDF-D5A8-8778F09DE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B37E7-983C-2BB8-A0AF-027D5BF62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742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AA0E04-3DAF-6B17-681D-371EB4674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0BC65-B6A0-34AB-CF5F-D0F247A4AA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657315-155E-1BDB-DD49-1CD195FF7F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ECA351-95FC-EBBD-F2F6-743432EFE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D069EE-6522-171E-CB1B-17ED14D63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4898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E06A0-2A98-8AF8-C139-5A9E670E8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17E86-04D3-8993-0BFF-CC6C806144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2B9F2F-66E2-DF7A-89E7-ED78217C2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A9E9C3-E49F-D0C7-C45B-D21E37C8E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4A9713-7ECE-7452-23C0-C25CE0EBB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7499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45FEBF-BB74-9704-B554-FE75799882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F70FDB-9E00-C8DA-2D81-1B2C435513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F6FDFFC-2DB0-BDDF-651A-7AE52A77F5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E30083C-2073-5ADD-C329-49501D3DA3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525A51-3E91-A43C-F35F-615AE08027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002E61-54EB-6B09-E839-86AE30603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395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6EC94C-E459-1C56-AC70-85C2D3CE9F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21BDCA-0841-3E14-5172-4AF4596D0C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1C4E3D-A682-DABB-EB83-6A0CD6A640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52E50CC-57D8-C811-02E0-0428B8BDF2A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340B599-99EB-EA18-02DC-C7236E23772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A2BFB6-65B6-1E2F-4F5E-A8031AEA7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3A36D43-CD18-6666-39BD-42328C341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9B7FCBD-4741-A3B1-CC77-152FFE5C2A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409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95C43B-1A75-51D9-DE34-BEC4EA8F96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63198CF-8F35-93F1-B551-D9E0E338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135F3DC-2991-ABE0-D271-188AC8EDF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AA5155-07F0-A588-A04A-CE8C8C91A4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1556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67B29C-5B5E-8870-7AC3-2E70E00BC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4AB518-4399-1CBF-2974-CEBDA14EE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EFD8A35-0561-B748-11D1-AF6ECF4EDD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731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5683B1-A80C-C557-C119-B14158A0C3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6483405-29CB-94B5-E58B-B7FBC41235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194D53A-89A5-8DFA-81A4-CFC79A0F7D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50D8AA-473F-663E-8927-5888F4C47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28318F3-45F9-4F1C-AA4B-C004A20FC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EAE9E4-54D0-1543-9084-704B1E36A9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241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4DBCE9-6809-A657-ECE6-5D67E5259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F3DBCC-1E41-31A9-1FA8-460388702E3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B01E945-2535-843F-0A1D-603EA46CB2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6D935D-5A91-5813-8265-1E72C4B60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9871DD-434A-9888-ED55-7C7FC92191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19E30F-5151-28BC-99BC-ABB860E55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2520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C284FA-B209-4EF7-B045-6F0C208D7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1382D-E939-9C9A-FA9C-DDA8EF6809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34C013-2113-6661-8960-CA009EDC7C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5B00AA7-C07B-4A06-91C6-F0AC1EA208F2}" type="datetimeFigureOut">
              <a:rPr lang="en-US" smtClean="0"/>
              <a:t>6/1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344A27-7B73-5DB2-1F24-FC69E0C972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423258-999A-A16C-E04E-C82CF2588A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C4D46A-5521-4758-9DBE-4D829027AA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142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1418CE0-D623-21C6-E813-A239C1C7815C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6760"/>
          <a:stretch>
            <a:fillRect/>
          </a:stretch>
        </p:blipFill>
        <p:spPr>
          <a:xfrm>
            <a:off x="1928902" y="643467"/>
            <a:ext cx="8334196" cy="24089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E6E2472-A23C-6CA6-9B60-278CDCB52382}"/>
              </a:ext>
            </a:extLst>
          </p:cNvPr>
          <p:cNvSpPr txBox="1"/>
          <p:nvPr/>
        </p:nvSpPr>
        <p:spPr>
          <a:xfrm>
            <a:off x="2640720" y="274134"/>
            <a:ext cx="609716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DDYDEPT(+79.97)DSLDAR</a:t>
            </a:r>
            <a:r>
              <a:rPr lang="en-US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9936E23-1F8A-343F-3CA9-2B6E1A3C921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6524"/>
          <a:stretch>
            <a:fillRect/>
          </a:stretch>
        </p:blipFill>
        <p:spPr>
          <a:xfrm>
            <a:off x="1928902" y="3792457"/>
            <a:ext cx="8334196" cy="24220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6C99152-8B75-141C-6783-8DDA67096F76}"/>
              </a:ext>
            </a:extLst>
          </p:cNvPr>
          <p:cNvSpPr txBox="1"/>
          <p:nvPr/>
        </p:nvSpPr>
        <p:spPr>
          <a:xfrm>
            <a:off x="2633012" y="3423124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VPRGEAAGAVQELARALAHLLEAERQE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694216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0B70BBB-91D6-2E21-1296-2D1413DE1A8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6288"/>
          <a:stretch>
            <a:fillRect/>
          </a:stretch>
        </p:blipFill>
        <p:spPr>
          <a:xfrm>
            <a:off x="1928902" y="643466"/>
            <a:ext cx="8334196" cy="243523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F7BDD05-9F9F-A9C6-DBA5-63CE2BDA3E2B}"/>
              </a:ext>
            </a:extLst>
          </p:cNvPr>
          <p:cNvSpPr txBox="1"/>
          <p:nvPr/>
        </p:nvSpPr>
        <p:spPr>
          <a:xfrm>
            <a:off x="2613277" y="274134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LGALFNPYFDPLQWKNSDFE</a:t>
            </a:r>
            <a:r>
              <a:rPr lang="en-US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1793EF6-3C3C-F5C4-80EE-12C41ECAB1B7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5934"/>
          <a:stretch>
            <a:fillRect/>
          </a:stretch>
        </p:blipFill>
        <p:spPr>
          <a:xfrm>
            <a:off x="1928902" y="3759565"/>
            <a:ext cx="8334196" cy="245496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BF2CDFD-4513-9378-ABFE-8B59C50E86A8}"/>
              </a:ext>
            </a:extLst>
          </p:cNvPr>
          <p:cNvSpPr txBox="1"/>
          <p:nvPr/>
        </p:nvSpPr>
        <p:spPr>
          <a:xfrm>
            <a:off x="2606698" y="3390233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M(+15.99)SPVPDLVPGSFK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774689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7F8D08B-2764-9524-7DB8-A6BD5CB2A6D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6052"/>
          <a:stretch>
            <a:fillRect/>
          </a:stretch>
        </p:blipFill>
        <p:spPr>
          <a:xfrm>
            <a:off x="1928902" y="643467"/>
            <a:ext cx="8334196" cy="244839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9E22BD0-5CB6-A45E-CEE5-CB3F0F95C251}"/>
              </a:ext>
            </a:extLst>
          </p:cNvPr>
          <p:cNvSpPr txBox="1"/>
          <p:nvPr/>
        </p:nvSpPr>
        <p:spPr>
          <a:xfrm>
            <a:off x="2619855" y="274134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Q(-17.03)ELEEELDEAVERSLQSILRKN</a:t>
            </a:r>
            <a:r>
              <a:rPr lang="en-US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919BCCD-88ED-ED66-0AA5-C31F4BBBA9C5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6406"/>
          <a:stretch>
            <a:fillRect/>
          </a:stretch>
        </p:blipFill>
        <p:spPr>
          <a:xfrm>
            <a:off x="1928902" y="3866890"/>
            <a:ext cx="8334196" cy="242865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3CB91D2-339A-3D46-208D-2D56273613FE}"/>
              </a:ext>
            </a:extLst>
          </p:cNvPr>
          <p:cNvSpPr txBox="1"/>
          <p:nvPr/>
        </p:nvSpPr>
        <p:spPr>
          <a:xfrm>
            <a:off x="2626434" y="3497558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DTEDKGEFLSEGGGVR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154723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41436BE-94AB-0332-9B80-40AAB1C7733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5934"/>
          <a:stretch>
            <a:fillRect/>
          </a:stretch>
        </p:blipFill>
        <p:spPr>
          <a:xfrm>
            <a:off x="1928902" y="643466"/>
            <a:ext cx="8334196" cy="24549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F034829-A385-E18B-CAA4-66D26DDAF854}"/>
              </a:ext>
            </a:extLst>
          </p:cNvPr>
          <p:cNvSpPr txBox="1"/>
          <p:nvPr/>
        </p:nvSpPr>
        <p:spPr>
          <a:xfrm>
            <a:off x="2613277" y="274134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TNEIVEEQYTPQSLATLESVFQELGKLTGPSNQ</a:t>
            </a:r>
            <a:r>
              <a:rPr lang="en-US" dirty="0"/>
              <a:t>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AD8C010-5698-AA5C-3F53-95B403CDB48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b="55579"/>
          <a:stretch>
            <a:fillRect/>
          </a:stretch>
        </p:blipFill>
        <p:spPr>
          <a:xfrm>
            <a:off x="1928902" y="3739830"/>
            <a:ext cx="8334196" cy="247470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71394D4-838B-14AC-D091-465AE04CBA6F}"/>
              </a:ext>
            </a:extLst>
          </p:cNvPr>
          <p:cNvSpPr txBox="1"/>
          <p:nvPr/>
        </p:nvSpPr>
        <p:spPr>
          <a:xfrm>
            <a:off x="2619855" y="3370497"/>
            <a:ext cx="609490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Y(+42.01)GGFM(+15.99)TSEKSQTPLVTLFKNAIIKNAH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202523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50616E2-0EA1-808A-070A-9DC4157C126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b="55697"/>
          <a:stretch>
            <a:fillRect/>
          </a:stretch>
        </p:blipFill>
        <p:spPr>
          <a:xfrm>
            <a:off x="1928902" y="643466"/>
            <a:ext cx="8334196" cy="246812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A72D41C-C677-4DDA-B7AE-41BE7D158BF7}"/>
              </a:ext>
            </a:extLst>
          </p:cNvPr>
          <p:cNvSpPr txBox="1"/>
          <p:nvPr/>
        </p:nvSpPr>
        <p:spPr>
          <a:xfrm>
            <a:off x="2613276" y="274134"/>
            <a:ext cx="7583271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RPVKVY(+79.97)PNVAENESAEAFPLEF or RPVKVYPNVAENES(+79.97)AEAFPLEF</a:t>
            </a:r>
            <a:r>
              <a:rPr lang="en-US" dirty="0"/>
              <a:t>  </a:t>
            </a:r>
          </a:p>
        </p:txBody>
      </p:sp>
    </p:spTree>
    <p:extLst>
      <p:ext uri="{BB962C8B-B14F-4D97-AF65-F5344CB8AC3E}">
        <p14:creationId xmlns:p14="http://schemas.microsoft.com/office/powerpoint/2010/main" val="1829533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39</Words>
  <Application>Microsoft Office PowerPoint</Application>
  <PresentationFormat>Widescreen</PresentationFormat>
  <Paragraphs>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yin Li</dc:creator>
  <cp:lastModifiedBy>Li, Keyin</cp:lastModifiedBy>
  <cp:revision>1</cp:revision>
  <dcterms:created xsi:type="dcterms:W3CDTF">2025-06-03T20:18:00Z</dcterms:created>
  <dcterms:modified xsi:type="dcterms:W3CDTF">2025-06-15T18:40:49Z</dcterms:modified>
</cp:coreProperties>
</file>